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1119" y="6381328"/>
            <a:ext cx="7852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2 Fig. Distributions of five barcode factors (GCC, HP, SR, HD, and CP) observed in random barcodes with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=10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751801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9741" y="22768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58213" y="22768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03329" y="436510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783861" y="4365104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f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3329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그림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9592" y="260648"/>
            <a:ext cx="3254400" cy="1808845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48064" y="260648"/>
            <a:ext cx="3254400" cy="1798846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592" y="2276872"/>
            <a:ext cx="3254400" cy="1802408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8064" y="2276872"/>
            <a:ext cx="3254400" cy="1805271"/>
          </a:xfrm>
          <a:prstGeom prst="rect">
            <a:avLst/>
          </a:prstGeom>
        </p:spPr>
      </p:pic>
      <p:pic>
        <p:nvPicPr>
          <p:cNvPr id="31" name="그림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9592" y="4365104"/>
            <a:ext cx="3254400" cy="1798846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48064" y="4365104"/>
            <a:ext cx="3254400" cy="1798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1975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3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38:03Z</dcterms:modified>
</cp:coreProperties>
</file>